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EA01B-B183-4D41-94CF-3C1D8EFD59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636BB-792C-40EA-9389-A95C788CCD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6B5CD-005B-4D1F-8ACC-934444F230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9C44D4-45D5-4AAD-A3B3-CFBDF1E81B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447635-BA2E-44A2-8C01-064906827E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2085D-4BA0-4637-8B84-845B07D102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3F5EA-9582-4518-AC89-BE7AE49BD2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97C4B-7C7A-4E44-9B33-D43875F467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9CCEF-81E9-4A3A-96BD-C929641E73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3C4BD-E968-4B92-ADA5-51EA92D825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883DF-A387-4646-B77E-A8AFE97FBA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0E1C6-091F-44DC-AD0C-FA0E9EDD04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3967FD-C8D1-4924-85F4-A20B11D851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2280" y="1066680"/>
          <a:ext cx="8834400" cy="3657600"/>
        </p:xfrm>
        <a:graphic>
          <a:graphicData uri="http://schemas.openxmlformats.org/drawingml/2006/table">
            <a:tbl>
              <a:tblPr/>
              <a:tblGrid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  <a:gridCol w="588960"/>
              </a:tblGrid>
              <a:tr h="204840"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CAN 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AF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P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L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ID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L-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C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EBER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hi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hi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3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hi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C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hi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PAF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P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887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hif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a89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L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ID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4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9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20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IC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444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CEBER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39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176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RD-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99ff33"/>
                    </a:solidFill>
                  </a:tcPr>
                </a:tc>
              </a:tr>
              <a:tr h="22212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S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99ff33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380880" y="4876920"/>
            <a:ext cx="5410440" cy="2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3520" y="5562720"/>
            <a:ext cx="228600" cy="152280"/>
          </a:xfrm>
          <a:prstGeom prst="rect">
            <a:avLst/>
          </a:prstGeom>
          <a:solidFill>
            <a:srgbClr val="ffa89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78840" y="5497560"/>
            <a:ext cx="360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ifted band corresponding to the protein compl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33520" y="6019920"/>
            <a:ext cx="228600" cy="1522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986040" y="5973840"/>
            <a:ext cx="162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o binding observ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4T16:46:53Z</dcterms:created>
  <dc:creator>Houston</dc:creator>
  <dc:description/>
  <dc:language>en-US</dc:language>
  <cp:lastModifiedBy>F PIO</cp:lastModifiedBy>
  <dcterms:modified xsi:type="dcterms:W3CDTF">2005-05-16T20:34:45Z</dcterms:modified>
  <cp:revision>21</cp:revision>
  <dc:subject/>
  <dc:title>Slide 1</dc:title>
</cp:coreProperties>
</file>